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71" r:id="rId10"/>
    <p:sldId id="263" r:id="rId11"/>
    <p:sldId id="264" r:id="rId12"/>
    <p:sldId id="265" r:id="rId13"/>
    <p:sldId id="266" r:id="rId14"/>
    <p:sldId id="267" r:id="rId15"/>
    <p:sldId id="268" r:id="rId16"/>
    <p:sldId id="272" r:id="rId17"/>
    <p:sldId id="270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88" autoAdjust="0"/>
    <p:restoredTop sz="94660"/>
  </p:normalViewPr>
  <p:slideViewPr>
    <p:cSldViewPr snapToGrid="0">
      <p:cViewPr varScale="1">
        <p:scale>
          <a:sx n="72" d="100"/>
          <a:sy n="72" d="100"/>
        </p:scale>
        <p:origin x="94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3264E7-0A4A-4B0A-A637-55864ACD41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1F543B6-0E84-43C5-8E66-04CA39EE03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0D79B29-78FC-4EBA-B094-BF0C9C1F8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C6425CE-7386-4261-9C63-9EF029B7E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9CA06EC-F8DC-49D2-8A50-3E6F18BEA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6223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9274F5-F348-4944-A5E2-FA154B69D2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3839E2E-1A5E-490B-8034-77A84971AC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B23E50-F013-47E3-A8C2-3D6ED8AFE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B374D6C-9C54-46C4-9637-C5CB83BC4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78C0726-A050-4511-8A9A-C74E1F235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0323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9118FAA-F543-4AE2-AD4F-C66DAB16CA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157EC10-AE92-4F21-9F99-E912EB8775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B75B99-11ED-48E0-84C3-114D0F829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778C79B-4BB6-411C-9DCD-9B351A68E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107A3CD-4E5B-4BC3-9B77-D8AEBE3CD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680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D4A51D-97F2-472B-B3DD-F08F769FC2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A4C6DD3-6D0C-47D5-8E93-85773EC748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ED0C78-02B6-4B80-870A-CBC6D9081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770F85-315F-49D8-8DF8-26E9798D4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37B31CE-B646-4583-BE26-3471584F3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513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5BA30E-B6C0-452E-A8EC-9FB011620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05D496E-95A6-4FBB-9554-B48A82FAB7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AD6818-BF8A-439D-978E-62DEEB2F4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28A082-8CCA-4199-AF0F-395827526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96B00FE-EE85-4041-86AE-95E7D5FC9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8579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83665D-2F20-4701-A547-CCA896319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6642AA3-4AC3-4DA7-B01D-1FBA5AD66D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EC5E4BB-0F43-48CA-A30E-1939A5AF5F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EAAA45B-008E-4D41-973C-89D9E91AA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0DFEA5C-676E-476F-BEDE-4ABF5CE72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73D09C3-C6CA-4963-906C-E60E4B44E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9298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3D18262-BF34-4940-9141-90298488E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8F21B65-B6B4-4F91-948D-8C05BEBFE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2F8BF21-E669-484F-BD71-181DEA00EB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EE5ABE5-4CCC-4F9F-BC90-C99073D319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A707B86-C29A-43CA-8291-75DB0F5C31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D210698-4F26-401C-93D4-1C33EBDFB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6FE821AA-D105-40DD-8C50-2B297E23A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B95E040-C623-4012-8590-0DB79FD04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18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E188E45-DA27-423D-A679-D60B51D5B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32847B9-0584-4808-8AEF-6B077B07E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74F425B-D1D1-43B9-B47A-3C999B666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2CC3F69-6A29-4B38-90F6-24D50EADE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089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05C91EE9-E1BF-485C-A672-9287533B4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F531CB1-9B54-4887-B16F-89335AD21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A326D7F-8786-431B-B22F-1E1E4928F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6253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FA5134-F274-40BC-A877-5065257BF9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10003D9-F41A-444A-90B3-BCF9B41F0D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D2519AD-C5A4-40F3-B439-35DE94F6E9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5F22E7F-E338-45F0-B9A6-52BF82FCD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54DD7BD-B409-4305-962D-DD274DEC6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DDEF74A-47F1-4B6F-8876-AA01213C6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51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5CAEFC-5381-48B2-9C71-2822C5104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97FB124-C5F9-46C8-A968-095CB357D3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697CC08-BF4F-46AE-B604-2675C2B0ED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4238B2-D981-4A74-AC4D-380D47F63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6646E4C-5749-47F1-BB35-606A23A38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68246C1-A198-4668-B8CA-D554B852E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678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19481A4-6A4E-4FF7-AA02-0DECD20AD9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433B737-BB46-4A61-8A2F-F99009E6D5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CEDE187-4A8B-43A0-A728-F09514492F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3D199-BDF4-4E1E-9079-5B615D563CD0}" type="datetimeFigureOut">
              <a:rPr lang="en-GB" smtClean="0"/>
              <a:t>13/05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1DF2B85-16BE-407D-AA21-3CF9518420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6138C4B-7CC7-49A8-B771-7C7C6C2AB4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58E060-0EBB-4C7C-8568-197071AEB37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5705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E6CE961-F95B-4ED1-9447-1C53929A3516}"/>
              </a:ext>
            </a:extLst>
          </p:cNvPr>
          <p:cNvSpPr/>
          <p:nvPr/>
        </p:nvSpPr>
        <p:spPr>
          <a:xfrm>
            <a:off x="0" y="546829"/>
            <a:ext cx="1138223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3200" b="1" u="sng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Data SD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710AE4E-F732-4BE2-ADB6-ECFF019BE5E4}"/>
              </a:ext>
            </a:extLst>
          </p:cNvPr>
          <p:cNvSpPr/>
          <p:nvPr/>
        </p:nvSpPr>
        <p:spPr>
          <a:xfrm>
            <a:off x="404883" y="1957764"/>
            <a:ext cx="11382233" cy="22595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2400" b="1" kern="1400" spc="-5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rtlisting SARS-CoV-2 peptides for targeted studies from experimental data-dependent acquisition tandem mass spectrometry data</a:t>
            </a: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uarte Gouveia, Lucia </a:t>
            </a:r>
            <a:r>
              <a:rPr lang="fr-FR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enga</a:t>
            </a: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Jean-Charles Gaillard, Fabrice Gallais, Laurent Bellanger, Olivier Pible, Jean Armengaud</a:t>
            </a:r>
            <a:r>
              <a:rPr lang="fr-FR" sz="14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#</a:t>
            </a:r>
            <a:endParaRPr lang="en-GB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fr-FR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versité Paris Saclay, CEA, INRAE, Département Médicaments et Technologies pour la Santé (DMTS), SPI, 30200 Bagnols-sur-Cèze, France.</a:t>
            </a:r>
            <a:endParaRPr lang="en-GB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12848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5BF728A1-3C06-4C51-A5AA-1014E35F29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2925" y="566734"/>
            <a:ext cx="7839075" cy="5724525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D9AB130C-2ED0-4328-93B8-EFCE94899C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995485"/>
            <a:ext cx="4219575" cy="286702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1112545-AD5E-4057-A78E-3ABD04C7BE83}"/>
              </a:ext>
            </a:extLst>
          </p:cNvPr>
          <p:cNvSpPr/>
          <p:nvPr/>
        </p:nvSpPr>
        <p:spPr>
          <a:xfrm>
            <a:off x="236561" y="6398925"/>
            <a:ext cx="109000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9 – LC peak and MS/MS spectra for the precursor </a:t>
            </a:r>
            <a:r>
              <a:rPr lang="en-GB" dirty="0"/>
              <a:t>ADETQALPQR 2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8532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2CE7245C-DF08-476F-AEBC-E454674026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18064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3B13CC56-8EA1-4B40-B194-EC5E71F050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1489" y="484848"/>
            <a:ext cx="7381875" cy="57245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ECE5428-3860-496D-AEAA-F022D723DF20}"/>
              </a:ext>
            </a:extLst>
          </p:cNvPr>
          <p:cNvSpPr/>
          <p:nvPr/>
        </p:nvSpPr>
        <p:spPr>
          <a:xfrm>
            <a:off x="0" y="6195729"/>
            <a:ext cx="104132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0 – LC peak and MS/MS spectra for the precursor </a:t>
            </a:r>
            <a:r>
              <a:rPr lang="en-GB" dirty="0"/>
              <a:t>GWIFGTTLDSK 2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10850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D2D4617F-F1F0-4E25-A0A9-AF6DBFA3C9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95" y="1995487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70C48C12-E3BE-4575-85C2-3D97C75BE5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86230" y="566736"/>
            <a:ext cx="7381875" cy="57245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7785D3E-C8B9-4A5A-B064-92CFDE6C9878}"/>
              </a:ext>
            </a:extLst>
          </p:cNvPr>
          <p:cNvSpPr/>
          <p:nvPr/>
        </p:nvSpPr>
        <p:spPr>
          <a:xfrm>
            <a:off x="123895" y="6331137"/>
            <a:ext cx="985261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1 – LC peak and MS/MS spectra for the precursor </a:t>
            </a:r>
            <a:r>
              <a:rPr lang="en-GB" dirty="0"/>
              <a:t>HTPINLVR 2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551505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F05B02F8-9E1D-4D51-B279-9C00DDD6D9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600" y="1995487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AF05A4E4-A5FF-40F5-95C3-614C16DF61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0125" y="566736"/>
            <a:ext cx="7381875" cy="57245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B745E77-3A1A-4B84-911B-42765DE79858}"/>
              </a:ext>
            </a:extLst>
          </p:cNvPr>
          <p:cNvSpPr/>
          <p:nvPr/>
        </p:nvSpPr>
        <p:spPr>
          <a:xfrm>
            <a:off x="96600" y="6399376"/>
            <a:ext cx="1102632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2 – LC peak and MS/MS spectra for the precursor </a:t>
            </a:r>
            <a:r>
              <a:rPr lang="en-GB" dirty="0"/>
              <a:t>FQTLLALHR 3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62034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AB10EBB9-9D50-40A9-87D1-C468D26EB3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985" y="1995487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A363749E-420D-4AFD-BE51-17CCE0807A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9140" y="566736"/>
            <a:ext cx="7381875" cy="57245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B53B4B9-5E87-4451-A474-153BD82851D4}"/>
              </a:ext>
            </a:extLst>
          </p:cNvPr>
          <p:cNvSpPr/>
          <p:nvPr/>
        </p:nvSpPr>
        <p:spPr>
          <a:xfrm>
            <a:off x="90984" y="6211669"/>
            <a:ext cx="914854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3 – LC peak and MS/MS spectra for the precursor </a:t>
            </a:r>
            <a:r>
              <a:rPr lang="en-GB" dirty="0"/>
              <a:t>LQSLQTYVTQQLIR 2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694747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FC4D4284-507B-4A01-A276-FC4FEA973E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543" y="1995487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8C3C7140-087D-484F-B50A-E5A6FFC2AF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2582" y="566736"/>
            <a:ext cx="7381875" cy="572452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C1A79A8-B4D4-458B-B155-A465FE9E8832}"/>
              </a:ext>
            </a:extLst>
          </p:cNvPr>
          <p:cNvSpPr/>
          <p:nvPr/>
        </p:nvSpPr>
        <p:spPr>
          <a:xfrm>
            <a:off x="-1" y="6211669"/>
            <a:ext cx="107817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4 – LC peak and MS/MS spectra for the precursor </a:t>
            </a:r>
            <a:r>
              <a:rPr lang="en-GB" dirty="0"/>
              <a:t>LQSLQTYVTQQLIR 3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133244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504A6C3-FFBB-4A57-A240-0FD41ACE65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86054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B775D73A-A760-46C4-A97E-132F617ADD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9575" y="266486"/>
            <a:ext cx="7381875" cy="57245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9183D87-00B3-4FA7-BF35-C61694CB4B5B}"/>
              </a:ext>
            </a:extLst>
          </p:cNvPr>
          <p:cNvSpPr/>
          <p:nvPr/>
        </p:nvSpPr>
        <p:spPr>
          <a:xfrm>
            <a:off x="113731" y="6097395"/>
            <a:ext cx="94533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5 – LC peak and MS/MS spectra for the precursor </a:t>
            </a:r>
            <a:r>
              <a:rPr lang="en-GB" dirty="0"/>
              <a:t>IAGHHLGR 2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026885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C7DA398-4899-4851-9819-73168A0222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95487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D68EE04D-B04B-400B-8B48-2DC0051F9D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0125" y="566736"/>
            <a:ext cx="7381875" cy="572452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08F06E7-6293-45F5-9EE8-DD4070BDDA47}"/>
              </a:ext>
            </a:extLst>
          </p:cNvPr>
          <p:cNvSpPr/>
          <p:nvPr/>
        </p:nvSpPr>
        <p:spPr>
          <a:xfrm>
            <a:off x="145576" y="6291261"/>
            <a:ext cx="1124575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6 – LC peak and MS/MS spectra for the precursor </a:t>
            </a:r>
            <a:r>
              <a:rPr lang="en-GB" dirty="0"/>
              <a:t>EITVATSR 2+</a:t>
            </a:r>
          </a:p>
        </p:txBody>
      </p:sp>
    </p:spTree>
    <p:extLst>
      <p:ext uri="{BB962C8B-B14F-4D97-AF65-F5344CB8AC3E}">
        <p14:creationId xmlns:p14="http://schemas.microsoft.com/office/powerpoint/2010/main" val="29806113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 13">
            <a:extLst>
              <a:ext uri="{FF2B5EF4-FFF2-40B4-BE49-F238E27FC236}">
                <a16:creationId xmlns:a16="http://schemas.microsoft.com/office/drawing/2014/main" id="{401E1B47-7B0A-4438-BDCE-AEF38DF1A2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1927" y="566737"/>
            <a:ext cx="7115175" cy="5724525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45395988-B044-47A0-9C18-AA7F2F841E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352" y="1995486"/>
            <a:ext cx="4219575" cy="286702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E8543F15-9BDC-4386-B64A-6F952AE6D093}"/>
              </a:ext>
            </a:extLst>
          </p:cNvPr>
          <p:cNvSpPr/>
          <p:nvPr/>
        </p:nvSpPr>
        <p:spPr>
          <a:xfrm>
            <a:off x="352352" y="6291260"/>
            <a:ext cx="113347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 – LC peak and MS/MS spectra for the precursor WYFYYLGTGPEAGLPYGANK 3+</a:t>
            </a:r>
          </a:p>
        </p:txBody>
      </p:sp>
    </p:spTree>
    <p:extLst>
      <p:ext uri="{BB962C8B-B14F-4D97-AF65-F5344CB8AC3E}">
        <p14:creationId xmlns:p14="http://schemas.microsoft.com/office/powerpoint/2010/main" val="378713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462693D7-6E6C-47C2-93CD-0F1DD8DD97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67713" y="566736"/>
            <a:ext cx="7115175" cy="5724525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F95834BE-E476-4DF6-82FB-FEAABEF7D9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511" y="1995485"/>
            <a:ext cx="4219575" cy="286702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5883539-DB25-4B11-96CF-658248EF8952}"/>
              </a:ext>
            </a:extLst>
          </p:cNvPr>
          <p:cNvSpPr/>
          <p:nvPr/>
        </p:nvSpPr>
        <p:spPr>
          <a:xfrm>
            <a:off x="468573" y="6291261"/>
            <a:ext cx="1125485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 – LC peak and MS/MS spectra for the precursor NPANNAAIVLQLPQGTTLPK 2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89981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6A47B142-2336-4461-AFC4-0B41842158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8564" y="276999"/>
            <a:ext cx="7115175" cy="5724525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B108F6B7-222E-4AD5-A01A-70C1D0BF4E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261" y="1678453"/>
            <a:ext cx="4219575" cy="286702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D6BCF98F-1DFB-42C9-BD1D-7F0DC203F6BC}"/>
              </a:ext>
            </a:extLst>
          </p:cNvPr>
          <p:cNvSpPr/>
          <p:nvPr/>
        </p:nvSpPr>
        <p:spPr>
          <a:xfrm>
            <a:off x="-1" y="6211669"/>
            <a:ext cx="1112292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 – LC peak and MS/MS spectra for the precursor NPANNAAIVLQLPQGTTLPK 3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33549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E1C8A8EA-4832-4235-A561-3866A5AC2C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441" y="2200204"/>
            <a:ext cx="4619625" cy="2867025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A83F1F38-889C-4ED9-97E7-14E5F4978B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4066" y="375669"/>
            <a:ext cx="7115175" cy="572452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D74EA74-F81B-4217-B455-D29023ED50A8}"/>
              </a:ext>
            </a:extLst>
          </p:cNvPr>
          <p:cNvSpPr/>
          <p:nvPr/>
        </p:nvSpPr>
        <p:spPr>
          <a:xfrm>
            <a:off x="172800" y="6182081"/>
            <a:ext cx="1010396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 – LC peak and MS/MS spectra for the precursor GFYAEGSR 2+ 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38296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EF1997DC-6142-449D-8A69-C2CAAEB0C1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0125" y="306587"/>
            <a:ext cx="7839075" cy="5724525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9608C1AF-838B-42B3-B1D9-421A02D319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800" y="1735336"/>
            <a:ext cx="3762375" cy="286702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B9A4FEA-7495-4176-A7A0-C9DD821B2496}"/>
              </a:ext>
            </a:extLst>
          </p:cNvPr>
          <p:cNvSpPr/>
          <p:nvPr/>
        </p:nvSpPr>
        <p:spPr>
          <a:xfrm>
            <a:off x="172800" y="6182081"/>
            <a:ext cx="1110025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 – LC peak and MS/MS spectra for the precursor AYNVTQAFGR 2+</a:t>
            </a:r>
          </a:p>
        </p:txBody>
      </p:sp>
    </p:spTree>
    <p:extLst>
      <p:ext uri="{BB962C8B-B14F-4D97-AF65-F5344CB8AC3E}">
        <p14:creationId xmlns:p14="http://schemas.microsoft.com/office/powerpoint/2010/main" val="20144621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AFD969E1-A413-48C9-934B-618F256649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018" y="1995485"/>
            <a:ext cx="3762375" cy="2867025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42E5054E-5AEE-4E59-AB66-704DF7CB36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2925" y="566736"/>
            <a:ext cx="7839075" cy="572452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6DAB583-46A5-43C8-95A8-D53367F9EB10}"/>
              </a:ext>
            </a:extLst>
          </p:cNvPr>
          <p:cNvSpPr/>
          <p:nvPr/>
        </p:nvSpPr>
        <p:spPr>
          <a:xfrm>
            <a:off x="0" y="6298085"/>
            <a:ext cx="117507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 – LC peak and MS/MS spectra for the precursor GPEQTQGNFGDQELIR 3+ 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68098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2A837925-2A35-421A-B406-0A6CB69DB3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7850" y="566736"/>
            <a:ext cx="7839075" cy="5724525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9ED7186C-A187-48FE-8885-CD6885BA22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995485"/>
            <a:ext cx="4219575" cy="286702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185656DD-AE4D-4B7E-9D59-AA2D4511BDDB}"/>
              </a:ext>
            </a:extLst>
          </p:cNvPr>
          <p:cNvSpPr/>
          <p:nvPr/>
        </p:nvSpPr>
        <p:spPr>
          <a:xfrm>
            <a:off x="175075" y="6291259"/>
            <a:ext cx="1083866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7 – LC peak and MS/MS spectra for the precursor IGMEVTPSGTWLTYTGAIK 3+ 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16998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86B827C-6F23-41E6-B53D-E4E1DADA62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95487"/>
            <a:ext cx="4219575" cy="28670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1564B30E-9922-4B72-BB68-B104405FC7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3689" y="566736"/>
            <a:ext cx="7381875" cy="57245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30B33124-855A-4FD8-84F3-121CC94C8887}"/>
              </a:ext>
            </a:extLst>
          </p:cNvPr>
          <p:cNvSpPr/>
          <p:nvPr/>
        </p:nvSpPr>
        <p:spPr>
          <a:xfrm>
            <a:off x="373038" y="6398925"/>
            <a:ext cx="983548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pt-PT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8 – LC peak and MS/MS spectra for the precursor </a:t>
            </a:r>
            <a:r>
              <a:rPr lang="en-GB" dirty="0"/>
              <a:t>VAGDSGFAAYSR 2+</a:t>
            </a:r>
            <a:endParaRPr lang="en-GB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45086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</TotalTime>
  <Words>337</Words>
  <Application>Microsoft Office PowerPoint</Application>
  <PresentationFormat>Grand écran</PresentationFormat>
  <Paragraphs>22</Paragraphs>
  <Slides>1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arte Gouveia</dc:creator>
  <cp:lastModifiedBy>jean Armengaud</cp:lastModifiedBy>
  <cp:revision>16</cp:revision>
  <dcterms:created xsi:type="dcterms:W3CDTF">2020-05-12T12:34:58Z</dcterms:created>
  <dcterms:modified xsi:type="dcterms:W3CDTF">2020-05-12T23:39:58Z</dcterms:modified>
</cp:coreProperties>
</file>